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522005-12A9-4B42-9418-202F1074E19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95907D-202E-4CF2-AC03-48EF4F9D32B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B775D5-354C-4C14-ACA4-B9BEDB97DC1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92883E-5973-4C14-8055-2C893080882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F69F16-4D9A-4923-9D87-429DDE6E422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1AB9FD-4BF7-4A64-88E3-C7E6D6638F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80F84A-BC19-473A-9FF5-8BA98CC4FF2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BD6082-6AE4-4803-9010-95A05F62840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217264-CF96-4DF8-AA43-DF6A6FFDF2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EDBA5C-5282-4FFE-A3BA-7AB1937286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073806-336E-49ED-95A9-9DB72530B7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831FE1-534A-4A20-858D-2EFF7BC17E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EB374A9-D17E-4D32-A49E-2DAFFF70077C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Image 2" descr="sup1a.pdf"/>
          <p:cNvPicPr/>
          <p:nvPr/>
        </p:nvPicPr>
        <p:blipFill>
          <a:blip r:embed="rId1"/>
          <a:stretch/>
        </p:blipFill>
        <p:spPr>
          <a:xfrm>
            <a:off x="65160" y="1565280"/>
            <a:ext cx="4343400" cy="2716200"/>
          </a:xfrm>
          <a:prstGeom prst="rect">
            <a:avLst/>
          </a:prstGeom>
          <a:ln w="0">
            <a:noFill/>
          </a:ln>
        </p:spPr>
      </p:pic>
      <p:pic>
        <p:nvPicPr>
          <p:cNvPr id="42" name="Image 3" descr="supp1b.pdf"/>
          <p:cNvPicPr/>
          <p:nvPr/>
        </p:nvPicPr>
        <p:blipFill>
          <a:blip r:embed="rId2"/>
          <a:stretch/>
        </p:blipFill>
        <p:spPr>
          <a:xfrm>
            <a:off x="4124160" y="1565280"/>
            <a:ext cx="4327560" cy="2716200"/>
          </a:xfrm>
          <a:prstGeom prst="rect">
            <a:avLst/>
          </a:prstGeom>
          <a:ln w="0">
            <a:noFill/>
          </a:ln>
        </p:spPr>
      </p:pic>
      <p:sp>
        <p:nvSpPr>
          <p:cNvPr id="43" name="ZoneTexte 4"/>
          <p:cNvSpPr/>
          <p:nvPr/>
        </p:nvSpPr>
        <p:spPr>
          <a:xfrm>
            <a:off x="6018120" y="1433520"/>
            <a:ext cx="527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100" spc="-1" strike="noStrike">
                <a:solidFill>
                  <a:srgbClr val="000000"/>
                </a:solidFill>
                <a:latin typeface="Calibri"/>
              </a:rPr>
              <a:t>N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ZoneTexte 6"/>
          <p:cNvSpPr/>
          <p:nvPr/>
        </p:nvSpPr>
        <p:spPr>
          <a:xfrm>
            <a:off x="716040" y="4811760"/>
            <a:ext cx="738648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upplementary figure 1. Glutathione peroxidase (GPx) activity (umol of NADPH/min/g of hemoglobin) and glutathione (GSH) levels (umol/mL of whole blood).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arenthèse fermante 17"/>
          <p:cNvSpPr/>
          <p:nvPr/>
        </p:nvSpPr>
        <p:spPr>
          <a:xfrm rot="16200000">
            <a:off x="6359400" y="1045800"/>
            <a:ext cx="46080" cy="1614600"/>
          </a:xfrm>
          <a:custGeom>
            <a:avLst/>
            <a:gdLst>
              <a:gd name="textAreaLeft" fmla="*/ 0 w 46080"/>
              <a:gd name="textAreaRight" fmla="*/ 32400 w 46080"/>
              <a:gd name="textAreaTop" fmla="*/ 1800 h 1614600"/>
              <a:gd name="textAreaBottom" fmla="*/ 1612800 h 16146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26"/>
                  <a:pt x="21600" y="51"/>
                </a:cubicBezTo>
                <a:lnTo>
                  <a:pt x="21600" y="21549"/>
                </a:lnTo>
                <a:cubicBezTo>
                  <a:pt x="21600" y="21575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ZoneTexte 18"/>
          <p:cNvSpPr/>
          <p:nvPr/>
        </p:nvSpPr>
        <p:spPr>
          <a:xfrm>
            <a:off x="2149560" y="1433520"/>
            <a:ext cx="525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100" spc="-1" strike="noStrike">
                <a:solidFill>
                  <a:srgbClr val="000000"/>
                </a:solidFill>
                <a:latin typeface="Calibri"/>
              </a:rPr>
              <a:t>N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arenthèse fermante 19"/>
          <p:cNvSpPr/>
          <p:nvPr/>
        </p:nvSpPr>
        <p:spPr>
          <a:xfrm rot="16200000">
            <a:off x="2296800" y="1082520"/>
            <a:ext cx="46080" cy="1614600"/>
          </a:xfrm>
          <a:custGeom>
            <a:avLst/>
            <a:gdLst>
              <a:gd name="textAreaLeft" fmla="*/ 0 w 46080"/>
              <a:gd name="textAreaRight" fmla="*/ 32400 w 46080"/>
              <a:gd name="textAreaTop" fmla="*/ 1800 h 1614600"/>
              <a:gd name="textAreaBottom" fmla="*/ 1612800 h 16146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26"/>
                  <a:pt x="21600" y="51"/>
                </a:cubicBezTo>
                <a:lnTo>
                  <a:pt x="21600" y="21549"/>
                </a:lnTo>
                <a:cubicBezTo>
                  <a:pt x="21600" y="21575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9-22T11:20:02Z</dcterms:created>
  <dc:creator>philipp baumann</dc:creator>
  <dc:description/>
  <dc:language>en-US</dc:language>
  <cp:lastModifiedBy>ravikumar.s</cp:lastModifiedBy>
  <dcterms:modified xsi:type="dcterms:W3CDTF">2016-07-15T11:00:18Z</dcterms:modified>
  <cp:revision>4</cp:revision>
  <dc:subject/>
  <dc:title>Présentation PowerPoint</dc:title>
</cp:coreProperties>
</file>